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59" autoAdjust="0"/>
    <p:restoredTop sz="94660"/>
  </p:normalViewPr>
  <p:slideViewPr>
    <p:cSldViewPr snapToGrid="0" showGuides="1">
      <p:cViewPr varScale="1">
        <p:scale>
          <a:sx n="117" d="100"/>
          <a:sy n="117" d="100"/>
        </p:scale>
        <p:origin x="-156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47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6522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4062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1097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1516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320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9433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422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7201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8592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738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8942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455234" y="6131080"/>
            <a:ext cx="702526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Times New Roman" panose="02020603050405020304" pitchFamily="18" charset="0"/>
              </a:rPr>
              <a:t>M, Protein standards, </a:t>
            </a:r>
            <a:r>
              <a:rPr lang="en-GB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kDa</a:t>
            </a:r>
            <a:r>
              <a:rPr lang="en-GB" dirty="0">
                <a:solidFill>
                  <a:srgbClr val="000000"/>
                </a:solidFill>
                <a:latin typeface="Times New Roman" panose="02020603050405020304" pitchFamily="18" charset="0"/>
              </a:rPr>
              <a:t>; A, applied; U, Unbound; 4-10, Fractions 4-10. </a:t>
            </a:r>
            <a:endParaRPr lang="en-GB" dirty="0"/>
          </a:p>
        </p:txBody>
      </p:sp>
      <p:grpSp>
        <p:nvGrpSpPr>
          <p:cNvPr id="13" name="Group 12"/>
          <p:cNvGrpSpPr/>
          <p:nvPr/>
        </p:nvGrpSpPr>
        <p:grpSpPr>
          <a:xfrm>
            <a:off x="1754257" y="1354453"/>
            <a:ext cx="5458662" cy="4662048"/>
            <a:chOff x="1754257" y="1097976"/>
            <a:chExt cx="5458662" cy="4662048"/>
          </a:xfrm>
        </p:grpSpPr>
        <p:grpSp>
          <p:nvGrpSpPr>
            <p:cNvPr id="4" name="Group 3"/>
            <p:cNvGrpSpPr/>
            <p:nvPr/>
          </p:nvGrpSpPr>
          <p:grpSpPr>
            <a:xfrm>
              <a:off x="2169755" y="1097976"/>
              <a:ext cx="5043164" cy="4662048"/>
              <a:chOff x="2147453" y="1298031"/>
              <a:chExt cx="5043164" cy="4662048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2147453" y="1298031"/>
                <a:ext cx="5043164" cy="4261938"/>
              </a:xfrm>
              <a:prstGeom prst="rect">
                <a:avLst/>
              </a:prstGeom>
            </p:spPr>
          </p:pic>
          <p:sp>
            <p:nvSpPr>
              <p:cNvPr id="3" name="Rectangle 2"/>
              <p:cNvSpPr/>
              <p:nvPr/>
            </p:nvSpPr>
            <p:spPr>
              <a:xfrm>
                <a:off x="2286000" y="5559969"/>
                <a:ext cx="4793673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2000" b="1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M    A    U     4       5     6    7      8       9    10 </a:t>
                </a:r>
                <a:endParaRPr lang="en-GB" sz="2000" dirty="0">
                  <a:solidFill>
                    <a:srgbClr val="000000"/>
                  </a:solidFill>
                  <a:latin typeface="Times New Roman" panose="02020603050405020304" pitchFamily="18" charset="0"/>
                </a:endParaRPr>
              </a:p>
            </p:txBody>
          </p:sp>
        </p:grpSp>
        <p:sp>
          <p:nvSpPr>
            <p:cNvPr id="7" name="Rectangle 6"/>
            <p:cNvSpPr/>
            <p:nvPr/>
          </p:nvSpPr>
          <p:spPr>
            <a:xfrm>
              <a:off x="1754257" y="4236793"/>
              <a:ext cx="41549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14</a:t>
              </a:r>
              <a:endParaRPr lang="en-GB" dirty="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1754257" y="2447365"/>
              <a:ext cx="41549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45</a:t>
              </a:r>
              <a:endParaRPr lang="en-GB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1754257" y="3068939"/>
              <a:ext cx="41549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31</a:t>
              </a:r>
              <a:endParaRPr lang="en-GB" dirty="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1754257" y="3756620"/>
              <a:ext cx="41549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21</a:t>
              </a:r>
              <a:endParaRPr lang="en-GB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1754257" y="2030015"/>
              <a:ext cx="41549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66</a:t>
              </a:r>
              <a:endParaRPr lang="en-GB" dirty="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1754663" y="1612665"/>
              <a:ext cx="41549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97</a:t>
              </a:r>
              <a:endParaRPr lang="en-GB" dirty="0"/>
            </a:p>
          </p:txBody>
        </p:sp>
      </p:grpSp>
      <p:sp>
        <p:nvSpPr>
          <p:cNvPr id="14" name="Rectangle 13"/>
          <p:cNvSpPr/>
          <p:nvPr/>
        </p:nvSpPr>
        <p:spPr>
          <a:xfrm>
            <a:off x="1193180" y="325247"/>
            <a:ext cx="7549376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dirty="0">
                <a:solidFill>
                  <a:srgbClr val="000000"/>
                </a:solidFill>
              </a:rPr>
              <a:t>S4 Fig. Analysis of final purified recombinant fraction by SDS-PAGE under reducing conditions, through a 4-20% gel. 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2696598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57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Y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Wilson</dc:creator>
  <cp:lastModifiedBy>Roopavathy</cp:lastModifiedBy>
  <cp:revision>4</cp:revision>
  <dcterms:created xsi:type="dcterms:W3CDTF">2019-08-28T10:03:25Z</dcterms:created>
  <dcterms:modified xsi:type="dcterms:W3CDTF">2020-02-17T06:20:24Z</dcterms:modified>
</cp:coreProperties>
</file>